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7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val>
            <c:numRef>
              <c:f>Sheet1!$N$108:$N$111</c:f>
              <c:numCache>
                <c:formatCode>General</c:formatCode>
                <c:ptCount val="4"/>
                <c:pt idx="0">
                  <c:v>23.701149425287358</c:v>
                </c:pt>
                <c:pt idx="1">
                  <c:v>1.0390658174097664</c:v>
                </c:pt>
                <c:pt idx="2">
                  <c:v>0.91288471570161722</c:v>
                </c:pt>
                <c:pt idx="3">
                  <c:v>3.55289421157684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E5-4B3D-AA4A-340246F912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793106207"/>
        <c:axId val="1793096607"/>
      </c:barChart>
      <c:catAx>
        <c:axId val="1793106207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3096607"/>
        <c:crosses val="autoZero"/>
        <c:auto val="1"/>
        <c:lblAlgn val="ctr"/>
        <c:lblOffset val="100"/>
        <c:noMultiLvlLbl val="0"/>
      </c:catAx>
      <c:valAx>
        <c:axId val="17930966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31062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3366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FF9-47F5-A0E1-AA8B2D323F7B}"/>
              </c:ext>
            </c:extLst>
          </c:dPt>
          <c:dPt>
            <c:idx val="1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FF9-47F5-A0E1-AA8B2D323F7B}"/>
              </c:ext>
            </c:extLst>
          </c:dPt>
          <c:dPt>
            <c:idx val="2"/>
            <c:invertIfNegative val="0"/>
            <c:bubble3D val="0"/>
            <c:spPr>
              <a:solidFill>
                <a:srgbClr val="3366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FF9-47F5-A0E1-AA8B2D323F7B}"/>
              </c:ext>
            </c:extLst>
          </c:dPt>
          <c:dPt>
            <c:idx val="3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FF9-47F5-A0E1-AA8B2D323F7B}"/>
              </c:ext>
            </c:extLst>
          </c:dPt>
          <c:dPt>
            <c:idx val="4"/>
            <c:invertIfNegative val="0"/>
            <c:bubble3D val="0"/>
            <c:spPr>
              <a:solidFill>
                <a:srgbClr val="3366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FF9-47F5-A0E1-AA8B2D323F7B}"/>
              </c:ext>
            </c:extLst>
          </c:dPt>
          <c:dPt>
            <c:idx val="5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FF9-47F5-A0E1-AA8B2D323F7B}"/>
              </c:ext>
            </c:extLst>
          </c:dPt>
          <c:dPt>
            <c:idx val="7"/>
            <c:invertIfNegative val="0"/>
            <c:bubble3D val="0"/>
            <c:spPr>
              <a:solidFill>
                <a:srgbClr val="00206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FF9-47F5-A0E1-AA8B2D323F7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V$65:$V$72</c:f>
                <c:numCache>
                  <c:formatCode>General</c:formatCode>
                  <c:ptCount val="8"/>
                  <c:pt idx="0">
                    <c:v>2.9000850704097827</c:v>
                  </c:pt>
                  <c:pt idx="1">
                    <c:v>4.7573562911409928</c:v>
                  </c:pt>
                  <c:pt idx="2">
                    <c:v>9.8279702832270228</c:v>
                  </c:pt>
                  <c:pt idx="3">
                    <c:v>4.3153451326311227</c:v>
                  </c:pt>
                  <c:pt idx="4">
                    <c:v>7.4058457314245381</c:v>
                  </c:pt>
                  <c:pt idx="5">
                    <c:v>5.6668328962030152</c:v>
                  </c:pt>
                  <c:pt idx="6">
                    <c:v>0.96666666666666667</c:v>
                  </c:pt>
                  <c:pt idx="7">
                    <c:v>2.9869105299069885</c:v>
                  </c:pt>
                </c:numCache>
              </c:numRef>
            </c:plus>
            <c:minus>
              <c:numRef>
                <c:f>Sheet1!$V$65:$V$72</c:f>
                <c:numCache>
                  <c:formatCode>General</c:formatCode>
                  <c:ptCount val="8"/>
                  <c:pt idx="0">
                    <c:v>2.9000850704097827</c:v>
                  </c:pt>
                  <c:pt idx="1">
                    <c:v>4.7573562911409928</c:v>
                  </c:pt>
                  <c:pt idx="2">
                    <c:v>9.8279702832270228</c:v>
                  </c:pt>
                  <c:pt idx="3">
                    <c:v>4.3153451326311227</c:v>
                  </c:pt>
                  <c:pt idx="4">
                    <c:v>7.4058457314245381</c:v>
                  </c:pt>
                  <c:pt idx="5">
                    <c:v>5.6668328962030152</c:v>
                  </c:pt>
                  <c:pt idx="6">
                    <c:v>0.96666666666666667</c:v>
                  </c:pt>
                  <c:pt idx="7">
                    <c:v>2.98691052990698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R$64:$R$71</c:f>
              <c:numCache>
                <c:formatCode>General</c:formatCode>
                <c:ptCount val="8"/>
                <c:pt idx="0">
                  <c:v>2.9</c:v>
                </c:pt>
                <c:pt idx="1">
                  <c:v>68.733333333333334</c:v>
                </c:pt>
                <c:pt idx="2">
                  <c:v>78.5</c:v>
                </c:pt>
                <c:pt idx="3">
                  <c:v>81.566666666666663</c:v>
                </c:pt>
                <c:pt idx="4">
                  <c:v>63.9</c:v>
                </c:pt>
                <c:pt idx="5">
                  <c:v>58.333333333333336</c:v>
                </c:pt>
                <c:pt idx="6">
                  <c:v>0.96666666666666667</c:v>
                </c:pt>
                <c:pt idx="7">
                  <c:v>5.9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9FF9-47F5-A0E1-AA8B2D323F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978086895"/>
        <c:axId val="1914363391"/>
      </c:barChart>
      <c:catAx>
        <c:axId val="1978086895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4363391"/>
        <c:crosses val="autoZero"/>
        <c:auto val="1"/>
        <c:lblAlgn val="ctr"/>
        <c:lblOffset val="100"/>
        <c:noMultiLvlLbl val="0"/>
      </c:catAx>
      <c:valAx>
        <c:axId val="191436339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780868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rgbClr val="00206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R$97:$R$104</c:f>
              <c:numCache>
                <c:formatCode>General</c:formatCode>
                <c:ptCount val="8"/>
                <c:pt idx="0">
                  <c:v>2.9</c:v>
                </c:pt>
                <c:pt idx="1">
                  <c:v>68.733333333333334</c:v>
                </c:pt>
                <c:pt idx="2">
                  <c:v>78.5</c:v>
                </c:pt>
                <c:pt idx="3">
                  <c:v>81.566666666666663</c:v>
                </c:pt>
                <c:pt idx="4">
                  <c:v>63.9</c:v>
                </c:pt>
                <c:pt idx="5">
                  <c:v>58.333333333333336</c:v>
                </c:pt>
                <c:pt idx="6">
                  <c:v>0.96666666666666667</c:v>
                </c:pt>
                <c:pt idx="7">
                  <c:v>5.9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93-41B2-A221-3B319A745F72}"/>
            </c:ext>
          </c:extLst>
        </c:ser>
        <c:ser>
          <c:idx val="1"/>
          <c:order val="1"/>
          <c:spPr>
            <a:solidFill>
              <a:srgbClr val="00660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S$97:$S$104</c:f>
              <c:numCache>
                <c:formatCode>General</c:formatCode>
                <c:ptCount val="8"/>
                <c:pt idx="0">
                  <c:v>16.166666666666668</c:v>
                </c:pt>
                <c:pt idx="1">
                  <c:v>22.983333333333334</c:v>
                </c:pt>
                <c:pt idx="2">
                  <c:v>13</c:v>
                </c:pt>
                <c:pt idx="3">
                  <c:v>11.166666666666666</c:v>
                </c:pt>
                <c:pt idx="4">
                  <c:v>17.760000000000002</c:v>
                </c:pt>
                <c:pt idx="5">
                  <c:v>31.166666666666668</c:v>
                </c:pt>
                <c:pt idx="6">
                  <c:v>18.766666666666669</c:v>
                </c:pt>
                <c:pt idx="7">
                  <c:v>21.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93-41B2-A221-3B319A745F72}"/>
            </c:ext>
          </c:extLst>
        </c:ser>
        <c:ser>
          <c:idx val="2"/>
          <c:order val="2"/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T$97:$T$104</c:f>
              <c:numCache>
                <c:formatCode>General</c:formatCode>
                <c:ptCount val="8"/>
                <c:pt idx="0">
                  <c:v>80.899999999999991</c:v>
                </c:pt>
                <c:pt idx="1">
                  <c:v>8.2833333333333332</c:v>
                </c:pt>
                <c:pt idx="2">
                  <c:v>8.3666666666666671</c:v>
                </c:pt>
                <c:pt idx="3">
                  <c:v>7.2</c:v>
                </c:pt>
                <c:pt idx="4">
                  <c:v>18.166666666666668</c:v>
                </c:pt>
                <c:pt idx="5">
                  <c:v>10.033333333333333</c:v>
                </c:pt>
                <c:pt idx="6">
                  <c:v>80.2</c:v>
                </c:pt>
                <c:pt idx="7">
                  <c:v>72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D93-41B2-A221-3B319A745F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100"/>
        <c:axId val="1974486175"/>
        <c:axId val="1974491455"/>
      </c:barChart>
      <c:catAx>
        <c:axId val="1974486175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74491455"/>
        <c:crosses val="autoZero"/>
        <c:auto val="1"/>
        <c:lblAlgn val="ctr"/>
        <c:lblOffset val="100"/>
        <c:noMultiLvlLbl val="0"/>
      </c:catAx>
      <c:valAx>
        <c:axId val="1974491455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7448617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57B76-A0DC-4D95-1E2D-60448059B3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2D807D-0C24-6D8A-C754-5BC714F4F4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0D593-7CD3-E95F-C9CE-D738C0EFB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0F4250-2B17-391A-73A2-113BB8B10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E8224-21FB-CDB4-716A-6465C0179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9474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1B574-631B-D682-40A0-28EDCEC8EF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40C3BE-AE83-E137-238F-F4694AE9CC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6BDF0-B015-AC15-62B7-1D73E7CB0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1E5E3F-A8A5-BC19-939B-B684126F4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F76469-FC87-0D80-7B4C-48A836353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254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07739E-1837-A160-263F-4234A9DACD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5A8B3C-FEDE-994F-DBB2-1BF45CF8DB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0E321B-3666-5B85-B077-6E4B819C1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9B441-EECD-F5C5-5D27-8296F2546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A4768-8F70-0057-B736-7D2545538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8490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FBE4E7-1AC2-0F2C-5901-04839A6CC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7126DA-7813-4818-FD99-8740B1BB10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6DB518-2CD3-6969-C062-ECB75F945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63DE77-2420-3D91-8809-09A36824B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6118C-B54A-4DFB-D03E-278AE0CE5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441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D61437-743A-3783-2638-C5AA9A2C8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8D9A56-AE46-BC7F-827C-738F893B16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26404-3BAD-6C49-DD51-CEA5C4CA7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5D9F3E-7831-8CCB-A95A-DF7DF738F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4B46A2-910B-760B-68E8-B06882468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294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B5343-C6C9-C29F-815B-F6D45E8DB9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1ACF0D-FE01-73AE-885C-69C8F61609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E74D86-4C4E-80E1-4DFB-EB8010E77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3C4407-4770-0AE8-7B0D-FCDBB870A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B9A7EA-51BE-1B4D-0581-E8E76809F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A52B76-0A2B-6C71-BBAE-46088AD5F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044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42E8A-B443-521A-A2C6-40600EDD8E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B869BB-E2BF-E8A9-A9F7-3DAC6E63C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7F5E79-DD0C-1275-032F-7BD5FB1D8A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5E0119-D97C-233A-29BD-9571D58048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6734C9-F098-F8E6-3417-F6E4A7E103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A2F204-1254-A0BA-8E39-A734150E6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2333B8-E5E3-27AC-3D7E-D24563213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4A62EA-3134-97FE-849F-7F9D6EC4D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58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092C2-C6EF-987F-B342-74B3200A2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C40808-A6E2-67E9-51D5-C3D127414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C89BC8-C24C-9C2F-8CC3-5B333B09E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F85806-5178-4433-3FAC-F4C0BF0D4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239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23B642-BB6A-E1CF-6A69-06076BDDB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29A6D7-24EC-F9BE-A95E-AB903E02C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347B60-3BFA-1E2F-1079-AF9FD8056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1433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C6CA2-D603-F638-32D8-B58BB8034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F8378C-EF7F-56C6-D4F3-FF9B771C29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47842B-9798-96DB-E9B0-9FA05AB8B3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C382F-F0D1-140E-A484-2C01784B8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2274B0-B973-1EA2-FF2B-04E24115F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898FB3-1818-CDCE-99A4-47C68BC67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7443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EE0E8-E083-963E-D02A-8D937F847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070BA5-9F26-6D8B-C8FC-C0D6D8648C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5DB42A-20A3-C55C-9530-C69641CA3B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C2D8E9-CC20-CAA8-C413-EEC607C52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B422D6-1292-3C24-8388-169377792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9F7C96-C7A7-1EDD-5B26-7DFB5E15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737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8A9249-B5C5-C064-B94F-B3769A63C9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8CCD4A-B2D6-419F-F752-96AF53B2D9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2322A0-FA58-44DD-83C6-EEC7CC6A1D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D29E4-7D6D-4586-A155-188BB5D19C1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2F59B5-C62F-5FE7-CAC9-B82F249C05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7681A1-F007-ABEB-556B-99BC7012DA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55888-43BB-43ED-9BE9-09EB1E3726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937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chart" Target="../charts/chart3.xml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38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chart" Target="../charts/chart1.xml"/><Relationship Id="rId40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4" Type="http://schemas.openxmlformats.org/officeDocument/2006/relationships/image" Target="../media/image4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43" Type="http://schemas.openxmlformats.org/officeDocument/2006/relationships/image" Target="../media/image39.png"/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341B7C99-DDBB-46BD-B29A-9D8BDE8B1868}"/>
              </a:ext>
            </a:extLst>
          </p:cNvPr>
          <p:cNvCxnSpPr/>
          <p:nvPr/>
        </p:nvCxnSpPr>
        <p:spPr>
          <a:xfrm>
            <a:off x="3393433" y="-1382825"/>
            <a:ext cx="89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8BFE97BF-076B-40E1-B3C2-5F9A6FBAB536}"/>
              </a:ext>
            </a:extLst>
          </p:cNvPr>
          <p:cNvSpPr txBox="1"/>
          <p:nvPr/>
        </p:nvSpPr>
        <p:spPr>
          <a:xfrm>
            <a:off x="5065566" y="6393400"/>
            <a:ext cx="53256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latin typeface="Arial Nova" panose="020B0504020202020204" pitchFamily="34" charset="0"/>
              </a:rPr>
              <a:t>-        +         -          +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E1C2647-6DC3-4A7A-8862-2C4DEA76525F}"/>
              </a:ext>
            </a:extLst>
          </p:cNvPr>
          <p:cNvGrpSpPr/>
          <p:nvPr/>
        </p:nvGrpSpPr>
        <p:grpSpPr>
          <a:xfrm>
            <a:off x="693126" y="6414666"/>
            <a:ext cx="9324767" cy="523220"/>
            <a:chOff x="778190" y="6265804"/>
            <a:chExt cx="9324767" cy="523220"/>
          </a:xfrm>
        </p:grpSpPr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96C54EBE-D634-4688-9911-1A35456B4309}"/>
                </a:ext>
              </a:extLst>
            </p:cNvPr>
            <p:cNvSpPr txBox="1"/>
            <p:nvPr/>
          </p:nvSpPr>
          <p:spPr>
            <a:xfrm>
              <a:off x="778190" y="6265804"/>
              <a:ext cx="754037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latin typeface="Arial Nova" panose="020B0504020202020204" pitchFamily="34" charset="0"/>
                </a:rPr>
                <a:t>-        +         -          +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86C3B61-8616-4C33-9735-1C32A2D748D8}"/>
                </a:ext>
              </a:extLst>
            </p:cNvPr>
            <p:cNvSpPr/>
            <p:nvPr/>
          </p:nvSpPr>
          <p:spPr>
            <a:xfrm>
              <a:off x="8706228" y="6318969"/>
              <a:ext cx="139672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latin typeface="Arial Nova" panose="020B0504020202020204" pitchFamily="34" charset="0"/>
                </a:rPr>
                <a:t>Sema4D-Fc</a:t>
              </a:r>
            </a:p>
          </p:txBody>
        </p: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F2571C9E-D568-A351-E9AA-801EEAF40B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687" y="580513"/>
            <a:ext cx="1007379" cy="116067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5B9F769-9B06-A96B-2187-EA6F85D20A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687" y="4169077"/>
            <a:ext cx="1006356" cy="115949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FA24F2D-1C2B-7281-C83F-4A31C1A32D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687" y="2972276"/>
            <a:ext cx="1007379" cy="116067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55EBD11-2641-564A-6A57-F19D77428D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8687" y="5376138"/>
            <a:ext cx="1001285" cy="115365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07039B3-8F92-7BB2-4E3D-350D0F217B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8687" y="1775262"/>
            <a:ext cx="1007379" cy="116067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FAE0818-8A4D-A7BA-C321-E6EEF711E73A}"/>
              </a:ext>
            </a:extLst>
          </p:cNvPr>
          <p:cNvSpPr txBox="1"/>
          <p:nvPr/>
        </p:nvSpPr>
        <p:spPr>
          <a:xfrm>
            <a:off x="308687" y="580513"/>
            <a:ext cx="1247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>
              <a:latin typeface="Arial Nova" panose="020B05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33BE7F7B-BD5B-49F2-D3B0-DB2A3F6B4E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52699" y="1775262"/>
            <a:ext cx="711556" cy="116067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72D631C-8D77-BA5D-D285-70812B6B819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52698" y="580513"/>
            <a:ext cx="711556" cy="116067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44368B41-B7A5-3C79-794C-9181882606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52698" y="4169077"/>
            <a:ext cx="710834" cy="115949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F8F1D234-8513-F874-8341-287069E5CF7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52699" y="2972276"/>
            <a:ext cx="711556" cy="116067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D9011B5-EA5C-28EF-A082-5E977C5595A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52699" y="5376138"/>
            <a:ext cx="711556" cy="1160675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A0E91137-9089-452F-A841-966DAFBDC26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5400000">
            <a:off x="2111651" y="1757523"/>
            <a:ext cx="1160677" cy="1196156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EB084CD8-BD6A-48BA-BBEC-BBEF1830D2C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2111652" y="2954537"/>
            <a:ext cx="1160676" cy="1196155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68E2E76-9B1E-466D-98A1-3D5AA36EF5F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rot="5400000">
            <a:off x="2111652" y="4151338"/>
            <a:ext cx="1160676" cy="1196154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19C5D9C9-26F3-4415-A343-6FE8BAEC63E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>
            <a:off x="2111652" y="5358399"/>
            <a:ext cx="1160676" cy="1196155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A7019C6-E6B4-4C27-B593-1F4DE062CA1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5400000">
            <a:off x="2111651" y="562774"/>
            <a:ext cx="1160677" cy="1196155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623363F4-F231-4C8F-8178-FA0AA18D8FC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rot="5400000">
            <a:off x="3392828" y="514938"/>
            <a:ext cx="1160676" cy="1291826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9653FFB1-1535-48A0-90DE-93AC4908BC5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 rot="5400000">
            <a:off x="3392827" y="1709687"/>
            <a:ext cx="1160675" cy="1291825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C9EFC560-3485-4896-A364-29F6C66965E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 rot="5400000">
            <a:off x="3392828" y="4103502"/>
            <a:ext cx="1160674" cy="129182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1E2CF1BA-908A-4181-BAA3-DDA76ED256C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rot="5400000">
            <a:off x="3392828" y="2906701"/>
            <a:ext cx="1160674" cy="1291824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47D7D2ED-410D-45AC-B3B7-024CFFCA82C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 rot="5400000">
            <a:off x="3393069" y="5310323"/>
            <a:ext cx="1164936" cy="1296567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515FF266-CD2D-4132-8A50-61EE2E792B6D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 rot="5400000">
            <a:off x="4560482" y="689231"/>
            <a:ext cx="1160677" cy="943241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8E84A22A-C318-4814-AEB9-3634AB1F6295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5400000">
            <a:off x="4560880" y="1883581"/>
            <a:ext cx="1156419" cy="939781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AE91F3BB-2B2A-4A19-9397-3D458DF9A0D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5400000">
            <a:off x="4561040" y="3080435"/>
            <a:ext cx="1154713" cy="938395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0CA3423E-916F-4BDF-918B-1E061BD2B077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5400000">
            <a:off x="4561040" y="4277236"/>
            <a:ext cx="1154713" cy="938395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EDC5D55C-33BC-428A-8729-DEAB55E31AF1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 rot="5400000">
            <a:off x="4561040" y="5484297"/>
            <a:ext cx="1154713" cy="938395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0CF1BE6B-375D-47FC-AEB6-363608001731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 rot="5400000">
            <a:off x="6582285" y="1791825"/>
            <a:ext cx="1164936" cy="1131810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CF6D646A-DC76-42B2-AE8E-0973BBE6B09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 rot="5400000">
            <a:off x="6582285" y="597076"/>
            <a:ext cx="1164936" cy="1131810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F1FB34EB-E3EF-4EEC-9068-DD100415835B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 rot="5400000">
            <a:off x="6582285" y="4185640"/>
            <a:ext cx="1164936" cy="1131810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AE48F910-26C2-491D-9617-703717CB726A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 rot="5400000">
            <a:off x="6582285" y="2988839"/>
            <a:ext cx="1164936" cy="113181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FC39C50F-5105-47FE-B226-07107A0A813D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 rot="5400000">
            <a:off x="6582285" y="5392701"/>
            <a:ext cx="1164936" cy="113181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33747220-A910-414A-8083-B50350BABC05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 rot="5400000">
            <a:off x="7746115" y="2993849"/>
            <a:ext cx="1164935" cy="1121789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31CC19C7-D4F6-407B-8A17-909F6E2CB1D0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 rot="5400000">
            <a:off x="7746116" y="602086"/>
            <a:ext cx="1164936" cy="1121790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508ACA2B-CC7C-4851-BEB7-0A38BF61B413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 rot="5400000">
            <a:off x="7746116" y="1796835"/>
            <a:ext cx="1164935" cy="1121789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35501C9E-4626-4AAE-8397-9B4EAE299844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 rot="5400000">
            <a:off x="7746116" y="4190650"/>
            <a:ext cx="1164934" cy="1121788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155454B2-3483-4729-86F2-DFDAF303B7F5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 rot="5400000">
            <a:off x="7746115" y="5397711"/>
            <a:ext cx="1164933" cy="11217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D673D46-F08C-400A-875F-1B79B3629547}"/>
              </a:ext>
            </a:extLst>
          </p:cNvPr>
          <p:cNvSpPr txBox="1"/>
          <p:nvPr/>
        </p:nvSpPr>
        <p:spPr>
          <a:xfrm rot="16200000">
            <a:off x="-324076" y="897587"/>
            <a:ext cx="972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00B050"/>
                </a:solidFill>
                <a:latin typeface="Arial Nova" panose="020B0504020202020204" pitchFamily="34" charset="0"/>
              </a:rPr>
              <a:t>Flag(AR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2EDF7B-AA38-49D8-8059-6FF084CC65DA}"/>
              </a:ext>
            </a:extLst>
          </p:cNvPr>
          <p:cNvSpPr txBox="1"/>
          <p:nvPr/>
        </p:nvSpPr>
        <p:spPr>
          <a:xfrm rot="16200000">
            <a:off x="-221805" y="2068817"/>
            <a:ext cx="7681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FF0000"/>
                </a:solidFill>
                <a:latin typeface="Arial Nova" panose="020B0504020202020204" pitchFamily="34" charset="0"/>
              </a:rPr>
              <a:t>cherr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4E6259-65D5-4C51-B296-FEA814E9592C}"/>
              </a:ext>
            </a:extLst>
          </p:cNvPr>
          <p:cNvSpPr txBox="1"/>
          <p:nvPr/>
        </p:nvSpPr>
        <p:spPr>
          <a:xfrm rot="16200000">
            <a:off x="-38775" y="3306332"/>
            <a:ext cx="4020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 Nova" panose="020B0504020202020204" pitchFamily="34" charset="0"/>
              </a:rPr>
              <a:t>F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6389A04-A04B-4E87-9F8F-296463FD72DA}"/>
              </a:ext>
            </a:extLst>
          </p:cNvPr>
          <p:cNvSpPr txBox="1"/>
          <p:nvPr/>
        </p:nvSpPr>
        <p:spPr>
          <a:xfrm rot="16200000">
            <a:off x="-156050" y="4533485"/>
            <a:ext cx="6366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rgbClr val="0000FF"/>
                </a:solidFill>
                <a:latin typeface="Arial Nova" panose="020B0504020202020204" pitchFamily="34" charset="0"/>
              </a:rPr>
              <a:t>DAP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5456968-14AD-41EB-9F43-C5B5312456B9}"/>
              </a:ext>
            </a:extLst>
          </p:cNvPr>
          <p:cNvSpPr txBox="1"/>
          <p:nvPr/>
        </p:nvSpPr>
        <p:spPr>
          <a:xfrm rot="16200000">
            <a:off x="-221613" y="5706900"/>
            <a:ext cx="7677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 Nova" panose="020B0504020202020204" pitchFamily="34" charset="0"/>
              </a:rPr>
              <a:t>merg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16BEA8-489A-40C7-B54E-CEB0C9C2B5F7}"/>
              </a:ext>
            </a:extLst>
          </p:cNvPr>
          <p:cNvSpPr txBox="1"/>
          <p:nvPr/>
        </p:nvSpPr>
        <p:spPr>
          <a:xfrm>
            <a:off x="971832" y="140067"/>
            <a:ext cx="8163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>
                <a:latin typeface="Arial Nova" panose="020B0504020202020204" pitchFamily="34" charset="0"/>
              </a:rPr>
              <a:t>Vec-ch</a:t>
            </a:r>
            <a:endParaRPr lang="en-GB" sz="1600" dirty="0">
              <a:latin typeface="Arial Nova" panose="020B05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4F772DD1-BD33-440F-B33A-BF8D7EB89C4F}"/>
              </a:ext>
            </a:extLst>
          </p:cNvPr>
          <p:cNvSpPr txBox="1"/>
          <p:nvPr/>
        </p:nvSpPr>
        <p:spPr>
          <a:xfrm>
            <a:off x="5274144" y="140067"/>
            <a:ext cx="1039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 Nova" panose="020B0504020202020204" pitchFamily="34" charset="0"/>
              </a:rPr>
              <a:t>RanQ69L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CD8EFA0-4F96-40EC-92B9-11D84B828CB4}"/>
              </a:ext>
            </a:extLst>
          </p:cNvPr>
          <p:cNvSpPr txBox="1"/>
          <p:nvPr/>
        </p:nvSpPr>
        <p:spPr>
          <a:xfrm>
            <a:off x="2959525" y="140067"/>
            <a:ext cx="12749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err="1">
                <a:latin typeface="Arial Nova" panose="020B0504020202020204" pitchFamily="34" charset="0"/>
              </a:rPr>
              <a:t>RanWT</a:t>
            </a:r>
            <a:endParaRPr lang="en-GB" sz="1600" dirty="0">
              <a:latin typeface="Arial Nova" panose="020B05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9FC7E51-09E0-4B8F-8DC4-3449ECF03067}"/>
              </a:ext>
            </a:extLst>
          </p:cNvPr>
          <p:cNvSpPr txBox="1"/>
          <p:nvPr/>
        </p:nvSpPr>
        <p:spPr>
          <a:xfrm>
            <a:off x="7249859" y="140067"/>
            <a:ext cx="10326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Arial Nova" panose="020B0504020202020204" pitchFamily="34" charset="0"/>
              </a:rPr>
              <a:t>RanT24N</a:t>
            </a:r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ACE1CDDC-BE52-4266-B5C2-5CE20047E198}"/>
              </a:ext>
            </a:extLst>
          </p:cNvPr>
          <p:cNvCxnSpPr>
            <a:cxnSpLocks/>
          </p:cNvCxnSpPr>
          <p:nvPr/>
        </p:nvCxnSpPr>
        <p:spPr>
          <a:xfrm>
            <a:off x="809329" y="514479"/>
            <a:ext cx="89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2EF3430E-A67F-422D-A9F9-50073D45D43C}"/>
              </a:ext>
            </a:extLst>
          </p:cNvPr>
          <p:cNvCxnSpPr>
            <a:cxnSpLocks/>
          </p:cNvCxnSpPr>
          <p:nvPr/>
        </p:nvCxnSpPr>
        <p:spPr>
          <a:xfrm>
            <a:off x="2877859" y="514479"/>
            <a:ext cx="89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CD1B182D-3363-41E8-9001-76094F000B73}"/>
              </a:ext>
            </a:extLst>
          </p:cNvPr>
          <p:cNvCxnSpPr>
            <a:cxnSpLocks/>
          </p:cNvCxnSpPr>
          <p:nvPr/>
        </p:nvCxnSpPr>
        <p:spPr>
          <a:xfrm>
            <a:off x="5169585" y="514479"/>
            <a:ext cx="89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3EBD4069-4225-4A1F-B900-530BCA90E650}"/>
              </a:ext>
            </a:extLst>
          </p:cNvPr>
          <p:cNvCxnSpPr>
            <a:cxnSpLocks/>
          </p:cNvCxnSpPr>
          <p:nvPr/>
        </p:nvCxnSpPr>
        <p:spPr>
          <a:xfrm>
            <a:off x="7164753" y="514479"/>
            <a:ext cx="8987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9254CA09-B1A8-4E82-BCAD-BA2EEA64897A}"/>
              </a:ext>
            </a:extLst>
          </p:cNvPr>
          <p:cNvSpPr txBox="1"/>
          <p:nvPr/>
        </p:nvSpPr>
        <p:spPr>
          <a:xfrm>
            <a:off x="41145" y="9453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A</a:t>
            </a:r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06D29E1E-E528-4C47-8CE3-7A86456BC07D}"/>
              </a:ext>
            </a:extLst>
          </p:cNvPr>
          <p:cNvSpPr/>
          <p:nvPr/>
        </p:nvSpPr>
        <p:spPr>
          <a:xfrm>
            <a:off x="205767" y="-81165"/>
            <a:ext cx="25079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Supplementary Figure 4 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C6B69A55-54D7-49FB-B378-A4C9F8384F74}"/>
              </a:ext>
            </a:extLst>
          </p:cNvPr>
          <p:cNvSpPr txBox="1"/>
          <p:nvPr/>
        </p:nvSpPr>
        <p:spPr>
          <a:xfrm>
            <a:off x="9057644" y="4608156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D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C7F3046-1F94-4328-9D95-E26F0CE9E476}"/>
              </a:ext>
            </a:extLst>
          </p:cNvPr>
          <p:cNvGrpSpPr/>
          <p:nvPr/>
        </p:nvGrpSpPr>
        <p:grpSpPr>
          <a:xfrm>
            <a:off x="9572660" y="4744768"/>
            <a:ext cx="2132213" cy="1990110"/>
            <a:chOff x="12874660" y="4630468"/>
            <a:chExt cx="2132213" cy="1990110"/>
          </a:xfrm>
        </p:grpSpPr>
        <p:graphicFrame>
          <p:nvGraphicFramePr>
            <p:cNvPr id="102" name="Chart 101">
              <a:extLst>
                <a:ext uri="{FF2B5EF4-FFF2-40B4-BE49-F238E27FC236}">
                  <a16:creationId xmlns:a16="http://schemas.microsoft.com/office/drawing/2014/main" id="{93ECCCE0-5503-4623-BDE9-8863FC11F1F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3294447" y="4716906"/>
            <a:ext cx="1712426" cy="12607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7"/>
            </a:graphicData>
          </a:graphic>
        </p:graphicFrame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DD3593F8-766D-4BAF-985A-2527F91E48E2}"/>
                </a:ext>
              </a:extLst>
            </p:cNvPr>
            <p:cNvSpPr txBox="1"/>
            <p:nvPr/>
          </p:nvSpPr>
          <p:spPr>
            <a:xfrm rot="16200000">
              <a:off x="14064345" y="6064100"/>
              <a:ext cx="733721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Q69L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890332DF-A5F6-44CD-9485-B88CB231C69E}"/>
                </a:ext>
              </a:extLst>
            </p:cNvPr>
            <p:cNvSpPr txBox="1"/>
            <p:nvPr/>
          </p:nvSpPr>
          <p:spPr>
            <a:xfrm rot="16200000">
              <a:off x="13552791" y="5753699"/>
              <a:ext cx="1134866" cy="3792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err="1">
                  <a:latin typeface="Arial Nova" panose="020B0504020202020204" pitchFamily="34" charset="0"/>
                </a:rPr>
                <a:t>RanWT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52E0CD15-15B5-4C7A-8164-003DA4B52EF0}"/>
                </a:ext>
              </a:extLst>
            </p:cNvPr>
            <p:cNvSpPr txBox="1"/>
            <p:nvPr/>
          </p:nvSpPr>
          <p:spPr>
            <a:xfrm rot="16200000">
              <a:off x="14394965" y="6055748"/>
              <a:ext cx="729439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T24N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D2B033E0-FAD9-4EB8-81C1-262B386B9D6D}"/>
                </a:ext>
              </a:extLst>
            </p:cNvPr>
            <p:cNvSpPr txBox="1"/>
            <p:nvPr/>
          </p:nvSpPr>
          <p:spPr>
            <a:xfrm rot="16200000">
              <a:off x="13504468" y="6006451"/>
              <a:ext cx="581154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control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45216814-48FD-45FD-8640-7E261B291D90}"/>
                </a:ext>
              </a:extLst>
            </p:cNvPr>
            <p:cNvSpPr txBox="1"/>
            <p:nvPr/>
          </p:nvSpPr>
          <p:spPr>
            <a:xfrm rot="16200000">
              <a:off x="12419376" y="5085752"/>
              <a:ext cx="143378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fold change  N&gt;C    </a:t>
              </a:r>
            </a:p>
            <a:p>
              <a:r>
                <a:rPr lang="en-GB" sz="1400" dirty="0"/>
                <a:t>S4D/control</a:t>
              </a:r>
            </a:p>
          </p:txBody>
        </p: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8283493C-D019-4218-95B6-A9B8209745B1}"/>
              </a:ext>
            </a:extLst>
          </p:cNvPr>
          <p:cNvGrpSpPr/>
          <p:nvPr/>
        </p:nvGrpSpPr>
        <p:grpSpPr>
          <a:xfrm>
            <a:off x="8915455" y="183391"/>
            <a:ext cx="3349796" cy="2292843"/>
            <a:chOff x="8883050" y="-63419"/>
            <a:chExt cx="3349796" cy="2292843"/>
          </a:xfrm>
        </p:grpSpPr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2CB3EA89-54E0-4DA3-92CD-2348649D25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629118" y="430572"/>
              <a:ext cx="354233" cy="73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0F79C3C-C147-422C-A5B6-F24718C71140}"/>
                </a:ext>
              </a:extLst>
            </p:cNvPr>
            <p:cNvSpPr txBox="1"/>
            <p:nvPr/>
          </p:nvSpPr>
          <p:spPr>
            <a:xfrm>
              <a:off x="9629118" y="109721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***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DD63D8A-7EAC-4FD3-9C29-E8370A0A5F9E}"/>
                </a:ext>
              </a:extLst>
            </p:cNvPr>
            <p:cNvSpPr txBox="1"/>
            <p:nvPr/>
          </p:nvSpPr>
          <p:spPr>
            <a:xfrm>
              <a:off x="10237704" y="-21454"/>
              <a:ext cx="3946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S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A15F22DB-9B7C-4B8F-B1C4-E2E5B7AD94C7}"/>
                </a:ext>
              </a:extLst>
            </p:cNvPr>
            <p:cNvSpPr txBox="1"/>
            <p:nvPr/>
          </p:nvSpPr>
          <p:spPr>
            <a:xfrm>
              <a:off x="10879060" y="292072"/>
              <a:ext cx="3946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S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56047E6-8B3F-487A-A4B6-F95013F493DF}"/>
                </a:ext>
              </a:extLst>
            </p:cNvPr>
            <p:cNvSpPr txBox="1"/>
            <p:nvPr/>
          </p:nvSpPr>
          <p:spPr>
            <a:xfrm>
              <a:off x="11510787" y="1190585"/>
              <a:ext cx="3946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S</a:t>
              </a:r>
            </a:p>
          </p:txBody>
        </p:sp>
        <p:graphicFrame>
          <p:nvGraphicFramePr>
            <p:cNvPr id="100" name="Chart 99">
              <a:extLst>
                <a:ext uri="{FF2B5EF4-FFF2-40B4-BE49-F238E27FC236}">
                  <a16:creationId xmlns:a16="http://schemas.microsoft.com/office/drawing/2014/main" id="{5BB4D0BE-AFEC-4AE4-B539-0CA8484A281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9180665" y="91958"/>
            <a:ext cx="2981574" cy="16696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8"/>
            </a:graphicData>
          </a:graphic>
        </p:graphicFrame>
        <p:grpSp>
          <p:nvGrpSpPr>
            <p:cNvPr id="178" name="Group 177">
              <a:extLst>
                <a:ext uri="{FF2B5EF4-FFF2-40B4-BE49-F238E27FC236}">
                  <a16:creationId xmlns:a16="http://schemas.microsoft.com/office/drawing/2014/main" id="{21FC853A-56DD-4029-8889-269337D60AEC}"/>
                </a:ext>
              </a:extLst>
            </p:cNvPr>
            <p:cNvGrpSpPr/>
            <p:nvPr/>
          </p:nvGrpSpPr>
          <p:grpSpPr>
            <a:xfrm>
              <a:off x="8985912" y="1529173"/>
              <a:ext cx="3246934" cy="700251"/>
              <a:chOff x="13578923" y="5083974"/>
              <a:chExt cx="3246934" cy="700251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83DC2B56-DC65-49D9-8860-361CA716A253}"/>
                  </a:ext>
                </a:extLst>
              </p:cNvPr>
              <p:cNvSpPr txBox="1"/>
              <p:nvPr/>
            </p:nvSpPr>
            <p:spPr>
              <a:xfrm>
                <a:off x="15314132" y="5404989"/>
                <a:ext cx="845909" cy="379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RanQ69L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1EEAB20F-1F6E-40E1-BA8B-F29CA08B3BCE}"/>
                  </a:ext>
                </a:extLst>
              </p:cNvPr>
              <p:cNvSpPr txBox="1"/>
              <p:nvPr/>
            </p:nvSpPr>
            <p:spPr>
              <a:xfrm>
                <a:off x="14708195" y="5404989"/>
                <a:ext cx="1308391" cy="379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 err="1">
                    <a:latin typeface="Arial Nova" panose="020B0504020202020204" pitchFamily="34" charset="0"/>
                  </a:rPr>
                  <a:t>RanWT</a:t>
                </a:r>
                <a:endParaRPr lang="en-GB" sz="12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B646E80D-43AF-4832-8B75-272ACEAFA99F}"/>
                  </a:ext>
                </a:extLst>
              </p:cNvPr>
              <p:cNvSpPr txBox="1"/>
              <p:nvPr/>
            </p:nvSpPr>
            <p:spPr>
              <a:xfrm>
                <a:off x="15984884" y="5404989"/>
                <a:ext cx="840973" cy="379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RanT24N</a:t>
                </a: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7C6FC61F-9CF8-43A4-BB87-9FAC138AB49D}"/>
                  </a:ext>
                </a:extLst>
              </p:cNvPr>
              <p:cNvSpPr txBox="1"/>
              <p:nvPr/>
            </p:nvSpPr>
            <p:spPr>
              <a:xfrm>
                <a:off x="14119680" y="5404989"/>
                <a:ext cx="670015" cy="379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control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8A14F8B9-180C-481F-91BB-285357631D3A}"/>
                  </a:ext>
                </a:extLst>
              </p:cNvPr>
              <p:cNvSpPr txBox="1"/>
              <p:nvPr/>
            </p:nvSpPr>
            <p:spPr>
              <a:xfrm>
                <a:off x="13578923" y="5091775"/>
                <a:ext cx="262659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S4D-Fc  </a:t>
                </a:r>
                <a:r>
                  <a:rPr lang="en-GB" sz="1600" dirty="0">
                    <a:latin typeface="Arial Nova" panose="020B0504020202020204" pitchFamily="34" charset="0"/>
                  </a:rPr>
                  <a:t>-    +    -    +</a:t>
                </a: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FFA434FB-C82D-48C5-AA9E-F7F36FED96D3}"/>
                  </a:ext>
                </a:extLst>
              </p:cNvPr>
              <p:cNvSpPr txBox="1"/>
              <p:nvPr/>
            </p:nvSpPr>
            <p:spPr>
              <a:xfrm>
                <a:off x="15435747" y="5083974"/>
                <a:ext cx="1211120" cy="4635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600" dirty="0">
                    <a:latin typeface="Arial Nova" panose="020B0504020202020204" pitchFamily="34" charset="0"/>
                  </a:rPr>
                  <a:t>-   +    -    +</a:t>
                </a:r>
              </a:p>
            </p:txBody>
          </p: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A727D752-51A7-4D35-BC8D-80E8CBBD52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64831" y="5386653"/>
                <a:ext cx="32267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>
                <a:extLst>
                  <a:ext uri="{FF2B5EF4-FFF2-40B4-BE49-F238E27FC236}">
                    <a16:creationId xmlns:a16="http://schemas.microsoft.com/office/drawing/2014/main" id="{41539D0D-8FF9-4CAD-8FE3-F6932E9092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892862" y="5386653"/>
                <a:ext cx="32267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054C85C7-263E-4242-AE79-D07E5E5CCF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20894" y="5386653"/>
                <a:ext cx="32267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E7A2BF9D-D3E5-4665-8462-86794350E9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148925" y="5386653"/>
                <a:ext cx="32267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B49346BB-91E7-4FA9-8C4B-0629545522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68295" y="248220"/>
              <a:ext cx="354233" cy="73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EAB865AD-FCDF-4389-8E75-EB18F52F9E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96327" y="521619"/>
              <a:ext cx="354233" cy="73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21657AE5-F528-4621-A15D-8BDF82B3027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24358" y="1417721"/>
              <a:ext cx="354233" cy="73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4B15B058-61D5-4B7A-BFFF-BAAA331E280F}"/>
                </a:ext>
              </a:extLst>
            </p:cNvPr>
            <p:cNvSpPr txBox="1"/>
            <p:nvPr/>
          </p:nvSpPr>
          <p:spPr>
            <a:xfrm>
              <a:off x="8883050" y="-63419"/>
              <a:ext cx="35779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b="1" dirty="0"/>
                <a:t>B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51F762A0-3358-42AF-8215-5DE7DBFA7C2F}"/>
                </a:ext>
              </a:extLst>
            </p:cNvPr>
            <p:cNvSpPr txBox="1"/>
            <p:nvPr/>
          </p:nvSpPr>
          <p:spPr>
            <a:xfrm rot="16200000">
              <a:off x="8666771" y="871695"/>
              <a:ext cx="10134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% cells N&gt;C</a:t>
              </a:r>
            </a:p>
          </p:txBody>
        </p:sp>
      </p:grp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D861BDBC-84C4-4714-B1EB-C0E043B7E1B2}"/>
              </a:ext>
            </a:extLst>
          </p:cNvPr>
          <p:cNvGrpSpPr/>
          <p:nvPr/>
        </p:nvGrpSpPr>
        <p:grpSpPr>
          <a:xfrm>
            <a:off x="8979189" y="2220586"/>
            <a:ext cx="3286062" cy="2533798"/>
            <a:chOff x="8946784" y="1973776"/>
            <a:chExt cx="3286062" cy="2533798"/>
          </a:xfrm>
        </p:grpSpPr>
        <p:grpSp>
          <p:nvGrpSpPr>
            <p:cNvPr id="220" name="Group 219">
              <a:extLst>
                <a:ext uri="{FF2B5EF4-FFF2-40B4-BE49-F238E27FC236}">
                  <a16:creationId xmlns:a16="http://schemas.microsoft.com/office/drawing/2014/main" id="{5BC90E35-450C-4EED-8CBC-A7F182580F46}"/>
                </a:ext>
              </a:extLst>
            </p:cNvPr>
            <p:cNvGrpSpPr/>
            <p:nvPr/>
          </p:nvGrpSpPr>
          <p:grpSpPr>
            <a:xfrm>
              <a:off x="8985912" y="2279991"/>
              <a:ext cx="3246934" cy="2227583"/>
              <a:chOff x="8985912" y="2279991"/>
              <a:chExt cx="3246934" cy="2227583"/>
            </a:xfrm>
          </p:grpSpPr>
          <p:graphicFrame>
            <p:nvGraphicFramePr>
              <p:cNvPr id="101" name="Chart 100">
                <a:extLst>
                  <a:ext uri="{FF2B5EF4-FFF2-40B4-BE49-F238E27FC236}">
                    <a16:creationId xmlns:a16="http://schemas.microsoft.com/office/drawing/2014/main" id="{4802B405-6233-483D-BFFF-72B9C372C751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9149726" y="2279991"/>
              <a:ext cx="3012513" cy="173830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9"/>
              </a:graphicData>
            </a:graphic>
          </p:graphicFrame>
          <p:grpSp>
            <p:nvGrpSpPr>
              <p:cNvPr id="209" name="Group 208">
                <a:extLst>
                  <a:ext uri="{FF2B5EF4-FFF2-40B4-BE49-F238E27FC236}">
                    <a16:creationId xmlns:a16="http://schemas.microsoft.com/office/drawing/2014/main" id="{9EBD5267-7E11-463E-B41C-ED0DB6DA27F4}"/>
                  </a:ext>
                </a:extLst>
              </p:cNvPr>
              <p:cNvGrpSpPr/>
              <p:nvPr/>
            </p:nvGrpSpPr>
            <p:grpSpPr>
              <a:xfrm>
                <a:off x="8985912" y="3807323"/>
                <a:ext cx="3246934" cy="700251"/>
                <a:chOff x="13578923" y="5083974"/>
                <a:chExt cx="3246934" cy="700251"/>
              </a:xfrm>
            </p:grpSpPr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8211FF4B-91D0-4B4C-8E0D-9A57A40F7D3B}"/>
                    </a:ext>
                  </a:extLst>
                </p:cNvPr>
                <p:cNvSpPr txBox="1"/>
                <p:nvPr/>
              </p:nvSpPr>
              <p:spPr>
                <a:xfrm>
                  <a:off x="15314132" y="5404989"/>
                  <a:ext cx="845909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Q69L</a:t>
                  </a:r>
                </a:p>
              </p:txBody>
            </p:sp>
            <p:sp>
              <p:nvSpPr>
                <p:cNvPr id="211" name="TextBox 210">
                  <a:extLst>
                    <a:ext uri="{FF2B5EF4-FFF2-40B4-BE49-F238E27FC236}">
                      <a16:creationId xmlns:a16="http://schemas.microsoft.com/office/drawing/2014/main" id="{E46682CF-2DB7-41F5-AB13-BA4BBC1D5387}"/>
                    </a:ext>
                  </a:extLst>
                </p:cNvPr>
                <p:cNvSpPr txBox="1"/>
                <p:nvPr/>
              </p:nvSpPr>
              <p:spPr>
                <a:xfrm>
                  <a:off x="14708195" y="5404989"/>
                  <a:ext cx="1308391" cy="379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 err="1">
                      <a:latin typeface="Arial Nova" panose="020B0504020202020204" pitchFamily="34" charset="0"/>
                    </a:rPr>
                    <a:t>RanWT</a:t>
                  </a:r>
                  <a:endParaRPr lang="en-GB" sz="12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212" name="TextBox 211">
                  <a:extLst>
                    <a:ext uri="{FF2B5EF4-FFF2-40B4-BE49-F238E27FC236}">
                      <a16:creationId xmlns:a16="http://schemas.microsoft.com/office/drawing/2014/main" id="{ABC4687F-AEFA-415D-8DB1-58DA98D8F132}"/>
                    </a:ext>
                  </a:extLst>
                </p:cNvPr>
                <p:cNvSpPr txBox="1"/>
                <p:nvPr/>
              </p:nvSpPr>
              <p:spPr>
                <a:xfrm>
                  <a:off x="15984884" y="5404989"/>
                  <a:ext cx="840973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T24N</a:t>
                  </a:r>
                </a:p>
              </p:txBody>
            </p:sp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01D48442-7F67-48A3-99CE-755C0FB5132D}"/>
                    </a:ext>
                  </a:extLst>
                </p:cNvPr>
                <p:cNvSpPr txBox="1"/>
                <p:nvPr/>
              </p:nvSpPr>
              <p:spPr>
                <a:xfrm>
                  <a:off x="14119680" y="5404989"/>
                  <a:ext cx="670015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57C5897E-7343-4EC7-84A2-3BAFDEF28F8B}"/>
                    </a:ext>
                  </a:extLst>
                </p:cNvPr>
                <p:cNvSpPr txBox="1"/>
                <p:nvPr/>
              </p:nvSpPr>
              <p:spPr>
                <a:xfrm>
                  <a:off x="13578923" y="5091775"/>
                  <a:ext cx="262659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S4D-Fc  </a:t>
                  </a:r>
                  <a:r>
                    <a:rPr lang="en-GB" sz="1600" dirty="0">
                      <a:latin typeface="Arial Nova" panose="020B0504020202020204" pitchFamily="34" charset="0"/>
                    </a:rPr>
                    <a:t>-    +    -    +</a:t>
                  </a:r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07CD7A9F-A32A-400D-8FFD-5D918F6B406D}"/>
                    </a:ext>
                  </a:extLst>
                </p:cNvPr>
                <p:cNvSpPr txBox="1"/>
                <p:nvPr/>
              </p:nvSpPr>
              <p:spPr>
                <a:xfrm>
                  <a:off x="15435747" y="5083974"/>
                  <a:ext cx="1211120" cy="4635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600" dirty="0">
                      <a:latin typeface="Arial Nova" panose="020B0504020202020204" pitchFamily="34" charset="0"/>
                    </a:rPr>
                    <a:t>-   +    -    +</a:t>
                  </a:r>
                </a:p>
              </p:txBody>
            </p:sp>
            <p:cxnSp>
              <p:nvCxnSpPr>
                <p:cNvPr id="216" name="Straight Connector 215">
                  <a:extLst>
                    <a:ext uri="{FF2B5EF4-FFF2-40B4-BE49-F238E27FC236}">
                      <a16:creationId xmlns:a16="http://schemas.microsoft.com/office/drawing/2014/main" id="{C1CE5E53-C460-41C3-AA81-BD01101028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64831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7" name="Straight Connector 216">
                  <a:extLst>
                    <a:ext uri="{FF2B5EF4-FFF2-40B4-BE49-F238E27FC236}">
                      <a16:creationId xmlns:a16="http://schemas.microsoft.com/office/drawing/2014/main" id="{6D8EB405-4F47-4D9E-8EDE-043FFFA85F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892862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Straight Connector 217">
                  <a:extLst>
                    <a:ext uri="{FF2B5EF4-FFF2-40B4-BE49-F238E27FC236}">
                      <a16:creationId xmlns:a16="http://schemas.microsoft.com/office/drawing/2014/main" id="{5DDF24AA-B2B9-4856-9D7C-A5EDD8685A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520894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Straight Connector 218">
                  <a:extLst>
                    <a:ext uri="{FF2B5EF4-FFF2-40B4-BE49-F238E27FC236}">
                      <a16:creationId xmlns:a16="http://schemas.microsoft.com/office/drawing/2014/main" id="{0F0D985F-4805-4059-B3C9-58B44E218D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148925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0882F347-5254-4750-AFD1-6F86D01F2371}"/>
                </a:ext>
              </a:extLst>
            </p:cNvPr>
            <p:cNvSpPr txBox="1"/>
            <p:nvPr/>
          </p:nvSpPr>
          <p:spPr>
            <a:xfrm>
              <a:off x="8946784" y="1973776"/>
              <a:ext cx="3481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b="1" dirty="0"/>
                <a:t>C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383221F1-642C-4A27-BBF5-29C165E84A08}"/>
                </a:ext>
              </a:extLst>
            </p:cNvPr>
            <p:cNvSpPr txBox="1"/>
            <p:nvPr/>
          </p:nvSpPr>
          <p:spPr>
            <a:xfrm rot="16200000">
              <a:off x="8786635" y="2939844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% cells </a:t>
              </a:r>
            </a:p>
          </p:txBody>
        </p: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F2D586D8-3C58-48BF-B499-B20292777FC3}"/>
              </a:ext>
            </a:extLst>
          </p:cNvPr>
          <p:cNvGrpSpPr/>
          <p:nvPr/>
        </p:nvGrpSpPr>
        <p:grpSpPr>
          <a:xfrm>
            <a:off x="11559400" y="4633835"/>
            <a:ext cx="562853" cy="570218"/>
            <a:chOff x="4593773" y="4050638"/>
            <a:chExt cx="562853" cy="570218"/>
          </a:xfrm>
        </p:grpSpPr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4352C5C6-D263-474B-B59A-597EBCDE1EC6}"/>
                </a:ext>
              </a:extLst>
            </p:cNvPr>
            <p:cNvSpPr/>
            <p:nvPr/>
          </p:nvSpPr>
          <p:spPr>
            <a:xfrm>
              <a:off x="4593773" y="4119118"/>
              <a:ext cx="134638" cy="138193"/>
            </a:xfrm>
            <a:prstGeom prst="rect">
              <a:avLst/>
            </a:prstGeom>
            <a:solidFill>
              <a:srgbClr val="00206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>
                <a:latin typeface="Arial Nova" panose="020B0504020202020204" pitchFamily="34" charset="0"/>
              </a:endParaRP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25BF24E3-D618-4445-8565-1900597C9165}"/>
                </a:ext>
              </a:extLst>
            </p:cNvPr>
            <p:cNvSpPr/>
            <p:nvPr/>
          </p:nvSpPr>
          <p:spPr>
            <a:xfrm>
              <a:off x="4593773" y="4271518"/>
              <a:ext cx="134638" cy="138193"/>
            </a:xfrm>
            <a:prstGeom prst="rect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>
                <a:latin typeface="Arial Nova" panose="020B0504020202020204" pitchFamily="34" charset="0"/>
              </a:endParaRP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BBB3CA75-A523-4916-9A34-1D13942C074B}"/>
                </a:ext>
              </a:extLst>
            </p:cNvPr>
            <p:cNvSpPr/>
            <p:nvPr/>
          </p:nvSpPr>
          <p:spPr>
            <a:xfrm>
              <a:off x="4593773" y="4423918"/>
              <a:ext cx="134638" cy="138193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>
                <a:latin typeface="Arial Nova" panose="020B0504020202020204" pitchFamily="34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C373E25-A2E4-41B4-AD45-786ED8E7B25C}"/>
                </a:ext>
              </a:extLst>
            </p:cNvPr>
            <p:cNvSpPr txBox="1"/>
            <p:nvPr/>
          </p:nvSpPr>
          <p:spPr>
            <a:xfrm>
              <a:off x="4662580" y="4050638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&gt;C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FB0E12B8-645D-4A6E-B13B-FE1C9BC5392B}"/>
                </a:ext>
              </a:extLst>
            </p:cNvPr>
            <p:cNvSpPr txBox="1"/>
            <p:nvPr/>
          </p:nvSpPr>
          <p:spPr>
            <a:xfrm>
              <a:off x="4662580" y="4189376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=C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ED98C01-C994-45BE-A115-971475E93EBC}"/>
                </a:ext>
              </a:extLst>
            </p:cNvPr>
            <p:cNvSpPr txBox="1"/>
            <p:nvPr/>
          </p:nvSpPr>
          <p:spPr>
            <a:xfrm>
              <a:off x="4662580" y="4343857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C&gt;N</a:t>
              </a:r>
            </a:p>
          </p:txBody>
        </p:sp>
      </p:grp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AAB175FD-CA0A-473A-82BA-E12F5550C9FC}"/>
              </a:ext>
            </a:extLst>
          </p:cNvPr>
          <p:cNvCxnSpPr>
            <a:cxnSpLocks/>
          </p:cNvCxnSpPr>
          <p:nvPr/>
        </p:nvCxnSpPr>
        <p:spPr>
          <a:xfrm flipH="1" flipV="1">
            <a:off x="1805297" y="1152013"/>
            <a:ext cx="139807" cy="160680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E9F57953-08CF-4FE7-AE6F-E89018BD660B}"/>
              </a:ext>
            </a:extLst>
          </p:cNvPr>
          <p:cNvCxnSpPr>
            <a:cxnSpLocks/>
          </p:cNvCxnSpPr>
          <p:nvPr/>
        </p:nvCxnSpPr>
        <p:spPr>
          <a:xfrm flipV="1">
            <a:off x="4986463" y="1329813"/>
            <a:ext cx="118514" cy="144941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0BD7BECB-2408-457B-80E6-3476AAEBB6B9}"/>
              </a:ext>
            </a:extLst>
          </p:cNvPr>
          <p:cNvCxnSpPr>
            <a:cxnSpLocks/>
          </p:cNvCxnSpPr>
          <p:nvPr/>
        </p:nvCxnSpPr>
        <p:spPr>
          <a:xfrm flipV="1">
            <a:off x="3531367" y="1253613"/>
            <a:ext cx="132598" cy="144941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113B4E82-4E86-40F4-B3F4-E3B82809C830}"/>
              </a:ext>
            </a:extLst>
          </p:cNvPr>
          <p:cNvCxnSpPr>
            <a:cxnSpLocks/>
          </p:cNvCxnSpPr>
          <p:nvPr/>
        </p:nvCxnSpPr>
        <p:spPr>
          <a:xfrm flipH="1" flipV="1">
            <a:off x="2923660" y="1329813"/>
            <a:ext cx="139807" cy="160680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7" name="Picture 136">
            <a:extLst>
              <a:ext uri="{FF2B5EF4-FFF2-40B4-BE49-F238E27FC236}">
                <a16:creationId xmlns:a16="http://schemas.microsoft.com/office/drawing/2014/main" id="{38F7E7D7-A4A1-4A8E-9189-B7A4899AB10F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 rot="16200000">
            <a:off x="5531300" y="1909739"/>
            <a:ext cx="1154716" cy="899270"/>
          </a:xfrm>
          <a:prstGeom prst="rect">
            <a:avLst/>
          </a:prstGeom>
        </p:spPr>
      </p:pic>
      <p:pic>
        <p:nvPicPr>
          <p:cNvPr id="138" name="Picture 137">
            <a:extLst>
              <a:ext uri="{FF2B5EF4-FFF2-40B4-BE49-F238E27FC236}">
                <a16:creationId xmlns:a16="http://schemas.microsoft.com/office/drawing/2014/main" id="{0BE3D550-C1AA-4008-8B5B-70C7D005658A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 rot="16200000">
            <a:off x="5530641" y="708893"/>
            <a:ext cx="1160675" cy="903911"/>
          </a:xfrm>
          <a:prstGeom prst="rect">
            <a:avLst/>
          </a:prstGeom>
        </p:spPr>
      </p:pic>
      <p:pic>
        <p:nvPicPr>
          <p:cNvPr id="139" name="Picture 138">
            <a:extLst>
              <a:ext uri="{FF2B5EF4-FFF2-40B4-BE49-F238E27FC236}">
                <a16:creationId xmlns:a16="http://schemas.microsoft.com/office/drawing/2014/main" id="{5B87D776-5C19-469D-96D6-02DC18B08C2D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 rot="16200000">
            <a:off x="5529873" y="4298228"/>
            <a:ext cx="1167621" cy="909321"/>
          </a:xfrm>
          <a:prstGeom prst="rect">
            <a:avLst/>
          </a:prstGeom>
        </p:spPr>
      </p:pic>
      <p:pic>
        <p:nvPicPr>
          <p:cNvPr id="140" name="Picture 139">
            <a:extLst>
              <a:ext uri="{FF2B5EF4-FFF2-40B4-BE49-F238E27FC236}">
                <a16:creationId xmlns:a16="http://schemas.microsoft.com/office/drawing/2014/main" id="{AC37EE71-028A-49DB-913D-DF432B8BEBB0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 rot="16200000">
            <a:off x="5531301" y="3099999"/>
            <a:ext cx="1154712" cy="899268"/>
          </a:xfrm>
          <a:prstGeom prst="rect">
            <a:avLst/>
          </a:prstGeom>
        </p:spPr>
      </p:pic>
      <p:pic>
        <p:nvPicPr>
          <p:cNvPr id="141" name="Picture 140">
            <a:extLst>
              <a:ext uri="{FF2B5EF4-FFF2-40B4-BE49-F238E27FC236}">
                <a16:creationId xmlns:a16="http://schemas.microsoft.com/office/drawing/2014/main" id="{D6AB050D-B520-46CE-ACAC-4596E9053BEB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 rot="16200000">
            <a:off x="5529873" y="5505289"/>
            <a:ext cx="1167621" cy="909321"/>
          </a:xfrm>
          <a:prstGeom prst="rect">
            <a:avLst/>
          </a:prstGeom>
        </p:spPr>
      </p:pic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4220328E-B0ED-4157-BB41-4FE5B8F2AF84}"/>
              </a:ext>
            </a:extLst>
          </p:cNvPr>
          <p:cNvCxnSpPr>
            <a:cxnSpLocks/>
          </p:cNvCxnSpPr>
          <p:nvPr/>
        </p:nvCxnSpPr>
        <p:spPr>
          <a:xfrm flipH="1" flipV="1">
            <a:off x="6179723" y="1291713"/>
            <a:ext cx="139807" cy="160680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A66DE27-23EE-C120-5C5D-92C7971BDDE9}"/>
              </a:ext>
            </a:extLst>
          </p:cNvPr>
          <p:cNvCxnSpPr/>
          <p:nvPr/>
        </p:nvCxnSpPr>
        <p:spPr>
          <a:xfrm>
            <a:off x="371075" y="6402760"/>
            <a:ext cx="23812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5136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4E3D346-A591-4F69-A0D9-6E6FA3E57C75}"/>
              </a:ext>
            </a:extLst>
          </p:cNvPr>
          <p:cNvSpPr/>
          <p:nvPr/>
        </p:nvSpPr>
        <p:spPr>
          <a:xfrm>
            <a:off x="931523" y="512385"/>
            <a:ext cx="8613169" cy="50471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4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ma4D-stimulated translocation of AR to the nucleus is dependent on Ran signalling  in MCF7 cells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ssociated with figure 1)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epresentative images of serum-starved MCF7 cells transfected with AR-Flag variant 2(green),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WT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Q69L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T24N (red),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gether with Fc empty vector or Sema4D-Fc (</a:t>
            </a:r>
            <a:r>
              <a:rPr lang="en-GB" sz="12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y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Arrows denote nuclear AR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x40 magnification scale bar= 20</a:t>
            </a:r>
            <a:r>
              <a:rPr lang="en-GB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 m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)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% cells in which intensity of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staining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nuclear AR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greater (N&gt;C), equal (N=C), or less (N&lt;C), than cytoplasmic staining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MCF7 cells co-transfected with AR-Flag variant 2,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WT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Q69L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T24N,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gether with Fc empty vector or Sema4D-Fc</a:t>
            </a: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elative number of cells in which staining of AR in the nucleus exceeded that in the cytoplasm following co-transfection with AR-Flag variant 2,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WT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Q69L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T24N,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gether with Fc empty vector or Sema4D-Fc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≥40 per condition per 3 independent experiments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*p=&lt;0.05, 2 tailed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udent T-Test, ns, not significant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)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ld change in nuclear AR in Sema4-Fc transfected/empty vector-transfected cells, in cells transfected with AR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WT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Q69L,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mCherry-RanT24N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1745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21</Words>
  <Application>Microsoft Office PowerPoint</Application>
  <PresentationFormat>Widescreen</PresentationFormat>
  <Paragraphs>4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Arial Nova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0:20Z</dcterms:created>
  <dcterms:modified xsi:type="dcterms:W3CDTF">2023-06-02T16:41:29Z</dcterms:modified>
</cp:coreProperties>
</file>